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39" autoAdjust="0"/>
    <p:restoredTop sz="94660"/>
  </p:normalViewPr>
  <p:slideViewPr>
    <p:cSldViewPr snapToGrid="0">
      <p:cViewPr varScale="1">
        <p:scale>
          <a:sx n="94" d="100"/>
          <a:sy n="94" d="100"/>
        </p:scale>
        <p:origin x="60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988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1177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8685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4424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8939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5513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065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72517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76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493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407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252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mp4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2097404" y="6193739"/>
            <a:ext cx="798639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Video 3. CFD animations of blood pressure and velocity over a cardiac cycle during full REBOA.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(A) Pressure distribution during f-REBOA (B) Velocity streamlines during f-REBOA. Videos have been slowed down to 1/5th of actual speed for easier viewing.</a:t>
            </a:r>
          </a:p>
        </p:txBody>
      </p:sp>
      <p:sp>
        <p:nvSpPr>
          <p:cNvPr id="7" name="Rectangle 6"/>
          <p:cNvSpPr/>
          <p:nvPr/>
        </p:nvSpPr>
        <p:spPr>
          <a:xfrm>
            <a:off x="2097404" y="818280"/>
            <a:ext cx="38717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6118928" y="818280"/>
            <a:ext cx="38717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2767542" y="818280"/>
            <a:ext cx="24136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Pressure (mmHg)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782172" y="818280"/>
            <a:ext cx="24136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Velocity (m/s)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5158167" y="5582547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2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6"/>
          <a:srcRect l="73536" t="12325" r="22150" b="7710"/>
          <a:stretch/>
        </p:blipFill>
        <p:spPr>
          <a:xfrm>
            <a:off x="4969947" y="1553854"/>
            <a:ext cx="260816" cy="4316627"/>
          </a:xfrm>
          <a:prstGeom prst="rect">
            <a:avLst/>
          </a:prstGeom>
        </p:spPr>
      </p:pic>
      <p:sp>
        <p:nvSpPr>
          <p:cNvPr id="23" name="Rectangle 22"/>
          <p:cNvSpPr/>
          <p:nvPr/>
        </p:nvSpPr>
        <p:spPr>
          <a:xfrm>
            <a:off x="5158167" y="5048449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4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5158167" y="4385981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6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5158167" y="3739650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8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5158167" y="3077182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0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5158167" y="2393138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2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5158167" y="1755924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4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7"/>
          <a:srcRect l="73819" t="12813" r="22349" b="7161"/>
          <a:stretch/>
        </p:blipFill>
        <p:spPr>
          <a:xfrm>
            <a:off x="9306148" y="1586773"/>
            <a:ext cx="239575" cy="4315968"/>
          </a:xfrm>
          <a:prstGeom prst="rect">
            <a:avLst/>
          </a:prstGeom>
        </p:spPr>
      </p:pic>
      <p:sp>
        <p:nvSpPr>
          <p:cNvPr id="39" name="Rectangle 38"/>
          <p:cNvSpPr/>
          <p:nvPr/>
        </p:nvSpPr>
        <p:spPr>
          <a:xfrm>
            <a:off x="9484384" y="5718075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9494587" y="5227104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0.2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1" name="Rectangle 40"/>
          <p:cNvSpPr/>
          <p:nvPr/>
        </p:nvSpPr>
        <p:spPr>
          <a:xfrm>
            <a:off x="9494587" y="4734747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0.4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2" name="Rectangle 41"/>
          <p:cNvSpPr/>
          <p:nvPr/>
        </p:nvSpPr>
        <p:spPr>
          <a:xfrm>
            <a:off x="9484384" y="4242390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0.6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3" name="Rectangle 42"/>
          <p:cNvSpPr/>
          <p:nvPr/>
        </p:nvSpPr>
        <p:spPr>
          <a:xfrm>
            <a:off x="9494587" y="3257676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.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9494587" y="2272962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.4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5" name="Rectangle 44"/>
          <p:cNvSpPr/>
          <p:nvPr/>
        </p:nvSpPr>
        <p:spPr>
          <a:xfrm>
            <a:off x="9494587" y="1780605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.6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6" name="Rectangle 45"/>
          <p:cNvSpPr/>
          <p:nvPr/>
        </p:nvSpPr>
        <p:spPr>
          <a:xfrm>
            <a:off x="9503846" y="2765319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.2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9484384" y="3750033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0.8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4113729" y="139194"/>
            <a:ext cx="396454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8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-REBOA</a:t>
            </a:r>
            <a:endParaRPr lang="en-US" sz="28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32" name="f-REBOA_Velocity_Video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8"/>
          <a:srcRect l="31322" t="7827" r="43594" b="1666"/>
          <a:stretch/>
        </p:blipFill>
        <p:spPr>
          <a:xfrm>
            <a:off x="6915996" y="1586773"/>
            <a:ext cx="1754660" cy="4366054"/>
          </a:xfrm>
          <a:prstGeom prst="rect">
            <a:avLst/>
          </a:prstGeom>
        </p:spPr>
      </p:pic>
      <p:pic>
        <p:nvPicPr>
          <p:cNvPr id="35" name="f-REBOA_Pressure_Video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9"/>
          <a:srcRect l="30973" t="8283" r="43590" b="2065"/>
          <a:stretch/>
        </p:blipFill>
        <p:spPr>
          <a:xfrm>
            <a:off x="2508652" y="1556602"/>
            <a:ext cx="1779373" cy="43248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80608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3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3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2"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3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5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3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5</TotalTime>
  <Words>77</Words>
  <Application>Microsoft Macintosh PowerPoint</Application>
  <PresentationFormat>Widescreen</PresentationFormat>
  <Paragraphs>22</Paragraphs>
  <Slides>1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WFB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onio Renaldo</dc:creator>
  <cp:lastModifiedBy>Ellie Rahbar, Ph.D.</cp:lastModifiedBy>
  <cp:revision>19</cp:revision>
  <dcterms:created xsi:type="dcterms:W3CDTF">2022-09-07T18:19:45Z</dcterms:created>
  <dcterms:modified xsi:type="dcterms:W3CDTF">2022-09-14T18:04:48Z</dcterms:modified>
</cp:coreProperties>
</file>